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699" r:id="rId2"/>
    <p:sldId id="697" r:id="rId3"/>
    <p:sldId id="684" r:id="rId4"/>
    <p:sldId id="686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B549"/>
    <a:srgbClr val="A8E8F9"/>
    <a:srgbClr val="9ECEFA"/>
    <a:srgbClr val="B0F7F1"/>
    <a:srgbClr val="00F8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463"/>
    <p:restoredTop sz="84969"/>
  </p:normalViewPr>
  <p:slideViewPr>
    <p:cSldViewPr snapToGrid="0" snapToObjects="1">
      <p:cViewPr varScale="1">
        <p:scale>
          <a:sx n="74" d="100"/>
          <a:sy n="74" d="100"/>
        </p:scale>
        <p:origin x="74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shi\Desktop\JAO&#25237;&#31295;\&#20107;&#21069;&#25351;&#31034;&#26360;&#35542;&#25991;\&#20107;&#21069;&#25351;&#31034;&#26360;\210%20LVAD&#12392;&#20107;&#21069;&#25351;&#31034;&#26360;2(&#32294;&#26029;&#30740;&#31350;)%20pure%20DT&#35299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shi\Desktop\JAO&#25237;&#31295;\&#20107;&#21069;&#25351;&#31034;&#26360;&#35542;&#25991;\&#20107;&#21069;&#25351;&#31034;&#26360;\210%20LVAD&#12392;&#20107;&#21069;&#25351;&#31034;&#26360;2(&#32294;&#26029;&#30740;&#31350;)%20pure%20DT&#35299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shi\Desktop\JAO&#25237;&#31295;\&#20107;&#21069;&#25351;&#31034;&#26360;&#35542;&#25991;\&#20107;&#21069;&#25351;&#31034;&#26360;\LVAD&#12392;&#20107;&#21069;&#25351;&#31034;&#26360;3(&#32294;&#26029;&#30740;&#31350;)%20DT&#8594;BTT&#35299;&#26512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shi\Desktop\JAO&#25237;&#31295;\&#20107;&#21069;&#25351;&#31034;&#26360;&#35542;&#25991;\&#20107;&#21069;&#25351;&#31034;&#26360;\LVAD&#12392;&#20107;&#21069;&#25351;&#31034;&#26360;3(&#32294;&#26029;&#30740;&#31350;)%20DT&#8594;BTT&#35299;&#26512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shi\Desktop\&#20107;&#21069;&#25351;&#31034;&#26360;&#35542;&#25991;\&#20107;&#21069;&#25351;&#31034;&#26360;\210%20LVAD&#12392;&#20107;&#21069;&#25351;&#31034;&#26360;2(&#32294;&#26029;&#30740;&#31350;)%20pure%20DT&#35299;&#26512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shi\Desktop\&#20107;&#21069;&#25351;&#31034;&#26360;&#35542;&#25991;\&#20107;&#21069;&#25351;&#31034;&#26360;\210%20LVAD&#12392;&#20107;&#21069;&#25351;&#31034;&#26360;2(&#32294;&#26029;&#30740;&#31350;)%20pure%20DT&#35299;&#26512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oshi\Desktop\&#20107;&#21069;&#25351;&#31034;&#26360;&#35542;&#25991;\&#20107;&#21069;&#25351;&#31034;&#26360;\LVAD&#12392;&#20107;&#21069;&#25351;&#31034;&#26360;3(&#32294;&#26029;&#30740;&#31350;)%20DT&#8594;BTT&#35299;&#26512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事後2解析 Pure DT1年後(n=8)  '!$A$27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事後2解析 Pure DT1年後(n=8) 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後2解析 Pure DT1年後(n=8)  '!$B$27:$O$27</c:f>
              <c:numCache>
                <c:formatCode>General</c:formatCode>
                <c:ptCount val="14"/>
                <c:pt idx="0">
                  <c:v>42.857142857142854</c:v>
                </c:pt>
                <c:pt idx="1">
                  <c:v>28.571428571428569</c:v>
                </c:pt>
                <c:pt idx="2">
                  <c:v>100</c:v>
                </c:pt>
                <c:pt idx="3">
                  <c:v>100</c:v>
                </c:pt>
                <c:pt idx="4">
                  <c:v>37.5</c:v>
                </c:pt>
                <c:pt idx="5">
                  <c:v>25</c:v>
                </c:pt>
                <c:pt idx="6">
                  <c:v>25</c:v>
                </c:pt>
                <c:pt idx="7">
                  <c:v>12.5</c:v>
                </c:pt>
                <c:pt idx="8">
                  <c:v>37.5</c:v>
                </c:pt>
                <c:pt idx="9">
                  <c:v>37.5</c:v>
                </c:pt>
                <c:pt idx="10">
                  <c:v>37.5</c:v>
                </c:pt>
                <c:pt idx="11">
                  <c:v>14.285714285714285</c:v>
                </c:pt>
                <c:pt idx="12">
                  <c:v>37.5</c:v>
                </c:pt>
                <c:pt idx="13">
                  <c:v>37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626-CE41-A759-2D1C5673C535}"/>
            </c:ext>
          </c:extLst>
        </c:ser>
        <c:ser>
          <c:idx val="1"/>
          <c:order val="1"/>
          <c:tx>
            <c:strRef>
              <c:f>'事後2解析 Pure DT1年後(n=8)  '!$A$28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C626-CE41-A759-2D1C5673C535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626-CE41-A759-2D1C5673C535}"/>
              </c:ext>
            </c:extLst>
          </c:dPt>
          <c:cat>
            <c:strRef>
              <c:f>'事後2解析 Pure DT1年後(n=8) 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後2解析 Pure DT1年後(n=8)  '!$B$28:$O$28</c:f>
              <c:numCache>
                <c:formatCode>General</c:formatCode>
                <c:ptCount val="14"/>
                <c:pt idx="0">
                  <c:v>57.142857142857139</c:v>
                </c:pt>
                <c:pt idx="1">
                  <c:v>71.428571428571431</c:v>
                </c:pt>
                <c:pt idx="2">
                  <c:v>0</c:v>
                </c:pt>
                <c:pt idx="3">
                  <c:v>0</c:v>
                </c:pt>
                <c:pt idx="4">
                  <c:v>12.5</c:v>
                </c:pt>
                <c:pt idx="5">
                  <c:v>12.5</c:v>
                </c:pt>
                <c:pt idx="6">
                  <c:v>12.5</c:v>
                </c:pt>
                <c:pt idx="7">
                  <c:v>12.5</c:v>
                </c:pt>
                <c:pt idx="8">
                  <c:v>12.5</c:v>
                </c:pt>
                <c:pt idx="9">
                  <c:v>12.5</c:v>
                </c:pt>
                <c:pt idx="10">
                  <c:v>12.5</c:v>
                </c:pt>
                <c:pt idx="11">
                  <c:v>14.285714285714285</c:v>
                </c:pt>
                <c:pt idx="12">
                  <c:v>12.5</c:v>
                </c:pt>
                <c:pt idx="13">
                  <c:v>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626-CE41-A759-2D1C5673C535}"/>
            </c:ext>
          </c:extLst>
        </c:ser>
        <c:ser>
          <c:idx val="2"/>
          <c:order val="2"/>
          <c:tx>
            <c:strRef>
              <c:f>'事後2解析 Pure DT1年後(n=8)  '!$A$29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事後2解析 Pure DT1年後(n=8) 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後2解析 Pure DT1年後(n=8)  '!$B$29:$O$29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50</c:v>
                </c:pt>
                <c:pt idx="5">
                  <c:v>62.5</c:v>
                </c:pt>
                <c:pt idx="6">
                  <c:v>62.5</c:v>
                </c:pt>
                <c:pt idx="7">
                  <c:v>75</c:v>
                </c:pt>
                <c:pt idx="8">
                  <c:v>50</c:v>
                </c:pt>
                <c:pt idx="9">
                  <c:v>50</c:v>
                </c:pt>
                <c:pt idx="10">
                  <c:v>50</c:v>
                </c:pt>
                <c:pt idx="11">
                  <c:v>71.428571428571431</c:v>
                </c:pt>
                <c:pt idx="12">
                  <c:v>50</c:v>
                </c:pt>
                <c:pt idx="13">
                  <c:v>37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626-CE41-A759-2D1C5673C5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0296208"/>
        <c:axId val="2090292400"/>
      </c:barChart>
      <c:catAx>
        <c:axId val="20902962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5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2400"/>
        <c:crosses val="autoZero"/>
        <c:auto val="1"/>
        <c:lblAlgn val="ctr"/>
        <c:lblOffset val="100"/>
        <c:noMultiLvlLbl val="0"/>
      </c:catAx>
      <c:valAx>
        <c:axId val="2090292400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6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事前2解析(n=8) '!$A$27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事前2解析(n=8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2解析(n=8) '!$B$27:$O$27</c:f>
              <c:numCache>
                <c:formatCode>General</c:formatCode>
                <c:ptCount val="14"/>
                <c:pt idx="0">
                  <c:v>25</c:v>
                </c:pt>
                <c:pt idx="1">
                  <c:v>42.857142857142854</c:v>
                </c:pt>
                <c:pt idx="2">
                  <c:v>100</c:v>
                </c:pt>
                <c:pt idx="3">
                  <c:v>100</c:v>
                </c:pt>
                <c:pt idx="4">
                  <c:v>50</c:v>
                </c:pt>
                <c:pt idx="5">
                  <c:v>37.5</c:v>
                </c:pt>
                <c:pt idx="6">
                  <c:v>37.5</c:v>
                </c:pt>
                <c:pt idx="7">
                  <c:v>12.5</c:v>
                </c:pt>
                <c:pt idx="8">
                  <c:v>50</c:v>
                </c:pt>
                <c:pt idx="9">
                  <c:v>50</c:v>
                </c:pt>
                <c:pt idx="10">
                  <c:v>50</c:v>
                </c:pt>
                <c:pt idx="11">
                  <c:v>28.571428571428569</c:v>
                </c:pt>
                <c:pt idx="12">
                  <c:v>50</c:v>
                </c:pt>
                <c:pt idx="13">
                  <c:v>62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08A-E945-8921-9B686E8B28D8}"/>
            </c:ext>
          </c:extLst>
        </c:ser>
        <c:ser>
          <c:idx val="1"/>
          <c:order val="1"/>
          <c:tx>
            <c:strRef>
              <c:f>'事前2解析(n=8) '!$A$28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D08A-E945-8921-9B686E8B28D8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08A-E945-8921-9B686E8B28D8}"/>
              </c:ext>
            </c:extLst>
          </c:dPt>
          <c:cat>
            <c:strRef>
              <c:f>'事前2解析(n=8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2解析(n=8) '!$B$28:$O$28</c:f>
              <c:numCache>
                <c:formatCode>General</c:formatCode>
                <c:ptCount val="14"/>
                <c:pt idx="0">
                  <c:v>75</c:v>
                </c:pt>
                <c:pt idx="1">
                  <c:v>57.142857142857139</c:v>
                </c:pt>
                <c:pt idx="2">
                  <c:v>0</c:v>
                </c:pt>
                <c:pt idx="3">
                  <c:v>0</c:v>
                </c:pt>
                <c:pt idx="4">
                  <c:v>50</c:v>
                </c:pt>
                <c:pt idx="5">
                  <c:v>62.5</c:v>
                </c:pt>
                <c:pt idx="6">
                  <c:v>62.5</c:v>
                </c:pt>
                <c:pt idx="7">
                  <c:v>62.5</c:v>
                </c:pt>
                <c:pt idx="8">
                  <c:v>50</c:v>
                </c:pt>
                <c:pt idx="9">
                  <c:v>50</c:v>
                </c:pt>
                <c:pt idx="10">
                  <c:v>50</c:v>
                </c:pt>
                <c:pt idx="11">
                  <c:v>57.142857142857139</c:v>
                </c:pt>
                <c:pt idx="12">
                  <c:v>37.5</c:v>
                </c:pt>
                <c:pt idx="13">
                  <c:v>37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08A-E945-8921-9B686E8B28D8}"/>
            </c:ext>
          </c:extLst>
        </c:ser>
        <c:ser>
          <c:idx val="2"/>
          <c:order val="2"/>
          <c:tx>
            <c:strRef>
              <c:f>'事前2解析(n=8) '!$A$29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事前2解析(n=8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2解析(n=8) '!$B$29:$O$29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5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4.285714285714285</c:v>
                </c:pt>
                <c:pt idx="12">
                  <c:v>12.5</c:v>
                </c:pt>
                <c:pt idx="1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08A-E945-8921-9B686E8B28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0301104"/>
        <c:axId val="2090294576"/>
      </c:barChart>
      <c:catAx>
        <c:axId val="20903011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5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4576"/>
        <c:crosses val="autoZero"/>
        <c:auto val="1"/>
        <c:lblAlgn val="ctr"/>
        <c:lblOffset val="100"/>
        <c:noMultiLvlLbl val="0"/>
      </c:catAx>
      <c:valAx>
        <c:axId val="209029457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3011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事前DT→BTT2解析(n=5) '!$A$27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事前DT→BTT2解析(n=5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DT→BTT2解析(n=5) '!$B$27:$O$27</c:f>
              <c:numCache>
                <c:formatCode>General</c:formatCode>
                <c:ptCount val="14"/>
                <c:pt idx="0">
                  <c:v>40</c:v>
                </c:pt>
                <c:pt idx="1">
                  <c:v>33.333333333333329</c:v>
                </c:pt>
                <c:pt idx="2">
                  <c:v>75</c:v>
                </c:pt>
                <c:pt idx="3">
                  <c:v>75</c:v>
                </c:pt>
                <c:pt idx="4">
                  <c:v>60</c:v>
                </c:pt>
                <c:pt idx="5">
                  <c:v>20</c:v>
                </c:pt>
                <c:pt idx="6">
                  <c:v>0</c:v>
                </c:pt>
                <c:pt idx="7">
                  <c:v>20</c:v>
                </c:pt>
                <c:pt idx="8">
                  <c:v>0</c:v>
                </c:pt>
                <c:pt idx="9">
                  <c:v>0</c:v>
                </c:pt>
                <c:pt idx="10">
                  <c:v>20</c:v>
                </c:pt>
                <c:pt idx="11">
                  <c:v>50</c:v>
                </c:pt>
                <c:pt idx="12">
                  <c:v>25</c:v>
                </c:pt>
                <c:pt idx="13">
                  <c:v>2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11B-334C-B5DD-7B172F09CF8F}"/>
            </c:ext>
          </c:extLst>
        </c:ser>
        <c:ser>
          <c:idx val="1"/>
          <c:order val="1"/>
          <c:tx>
            <c:strRef>
              <c:f>'事前DT→BTT2解析(n=5) '!$A$28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6-111B-334C-B5DD-7B172F09CF8F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11B-334C-B5DD-7B172F09CF8F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111B-334C-B5DD-7B172F09CF8F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11B-334C-B5DD-7B172F09CF8F}"/>
              </c:ext>
            </c:extLst>
          </c:dPt>
          <c:cat>
            <c:strRef>
              <c:f>'事前DT→BTT2解析(n=5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DT→BTT2解析(n=5) '!$B$28:$O$28</c:f>
              <c:numCache>
                <c:formatCode>General</c:formatCode>
                <c:ptCount val="14"/>
                <c:pt idx="0">
                  <c:v>60</c:v>
                </c:pt>
                <c:pt idx="1">
                  <c:v>66.666666666666657</c:v>
                </c:pt>
                <c:pt idx="2">
                  <c:v>25</c:v>
                </c:pt>
                <c:pt idx="3">
                  <c:v>25</c:v>
                </c:pt>
                <c:pt idx="4">
                  <c:v>40</c:v>
                </c:pt>
                <c:pt idx="5">
                  <c:v>60</c:v>
                </c:pt>
                <c:pt idx="6">
                  <c:v>100</c:v>
                </c:pt>
                <c:pt idx="7">
                  <c:v>40</c:v>
                </c:pt>
                <c:pt idx="8">
                  <c:v>60</c:v>
                </c:pt>
                <c:pt idx="9">
                  <c:v>80</c:v>
                </c:pt>
                <c:pt idx="10">
                  <c:v>60</c:v>
                </c:pt>
                <c:pt idx="11">
                  <c:v>25</c:v>
                </c:pt>
                <c:pt idx="12">
                  <c:v>50</c:v>
                </c:pt>
                <c:pt idx="13">
                  <c:v>6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11B-334C-B5DD-7B172F09CF8F}"/>
            </c:ext>
          </c:extLst>
        </c:ser>
        <c:ser>
          <c:idx val="2"/>
          <c:order val="2"/>
          <c:tx>
            <c:strRef>
              <c:f>'事前DT→BTT2解析(n=5) '!$A$29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事前DT→BTT2解析(n=5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DT→BTT2解析(n=5) '!$B$29:$O$29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0</c:v>
                </c:pt>
                <c:pt idx="6">
                  <c:v>0</c:v>
                </c:pt>
                <c:pt idx="7">
                  <c:v>40</c:v>
                </c:pt>
                <c:pt idx="8">
                  <c:v>40</c:v>
                </c:pt>
                <c:pt idx="9">
                  <c:v>20</c:v>
                </c:pt>
                <c:pt idx="10">
                  <c:v>20</c:v>
                </c:pt>
                <c:pt idx="11">
                  <c:v>25</c:v>
                </c:pt>
                <c:pt idx="12">
                  <c:v>25</c:v>
                </c:pt>
                <c:pt idx="13">
                  <c:v>2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11B-334C-B5DD-7B172F09CF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0301648"/>
        <c:axId val="2090291856"/>
      </c:barChart>
      <c:catAx>
        <c:axId val="20903016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5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1856"/>
        <c:crosses val="autoZero"/>
        <c:auto val="1"/>
        <c:lblAlgn val="ctr"/>
        <c:lblOffset val="100"/>
        <c:noMultiLvlLbl val="0"/>
      </c:catAx>
      <c:valAx>
        <c:axId val="2090291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301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事前DT→BTT21年後解析(n=5) '!$A$27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事前DT→BTT21年後解析(n=5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DT→BTT21年後解析(n=5) '!$B$27:$O$27</c:f>
              <c:numCache>
                <c:formatCode>General</c:formatCode>
                <c:ptCount val="14"/>
                <c:pt idx="0">
                  <c:v>60</c:v>
                </c:pt>
                <c:pt idx="1">
                  <c:v>0</c:v>
                </c:pt>
                <c:pt idx="4">
                  <c:v>2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20</c:v>
                </c:pt>
                <c:pt idx="13">
                  <c:v>2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F42-D248-8EA4-D87C9159A52D}"/>
            </c:ext>
          </c:extLst>
        </c:ser>
        <c:ser>
          <c:idx val="1"/>
          <c:order val="1"/>
          <c:tx>
            <c:strRef>
              <c:f>'事前DT→BTT21年後解析(n=5) '!$A$28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F42-D248-8EA4-D87C9159A52D}"/>
              </c:ext>
            </c:extLst>
          </c:dPt>
          <c:cat>
            <c:strRef>
              <c:f>'事前DT→BTT21年後解析(n=5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DT→BTT21年後解析(n=5) '!$B$28:$O$28</c:f>
              <c:numCache>
                <c:formatCode>General</c:formatCode>
                <c:ptCount val="14"/>
                <c:pt idx="0">
                  <c:v>40</c:v>
                </c:pt>
                <c:pt idx="1">
                  <c:v>0</c:v>
                </c:pt>
                <c:pt idx="4">
                  <c:v>8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0</c:v>
                </c:pt>
                <c:pt idx="12">
                  <c:v>80</c:v>
                </c:pt>
                <c:pt idx="13">
                  <c:v>8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F42-D248-8EA4-D87C9159A52D}"/>
            </c:ext>
          </c:extLst>
        </c:ser>
        <c:ser>
          <c:idx val="2"/>
          <c:order val="2"/>
          <c:tx>
            <c:strRef>
              <c:f>'事前DT→BTT21年後解析(n=5) '!$A$29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事前DT→BTT21年後解析(n=5) '!$B$26:$O$26</c:f>
              <c:strCache>
                <c:ptCount val="14"/>
                <c:pt idx="0">
                  <c:v>End-of-life at home</c:v>
                </c:pt>
                <c:pt idx="1">
                  <c:v>Deep sedation</c:v>
                </c:pt>
                <c:pt idx="2">
                  <c:v>Sedation</c:v>
                </c:pt>
                <c:pt idx="3">
                  <c:v>Pain relief</c:v>
                </c:pt>
                <c:pt idx="4">
                  <c:v>Intravenous feeding</c:v>
                </c:pt>
                <c:pt idx="5">
                  <c:v>Nasogastric tube</c:v>
                </c:pt>
                <c:pt idx="6">
                  <c:v>Gastrostomy tube</c:v>
                </c:pt>
                <c:pt idx="7">
                  <c:v>Hemodialysis</c:v>
                </c:pt>
                <c:pt idx="8">
                  <c:v>Chest compression</c:v>
                </c:pt>
                <c:pt idx="9">
                  <c:v> Artificial heart-lung</c:v>
                </c:pt>
                <c:pt idx="10">
                  <c:v>Mechanical ventilation</c:v>
                </c:pt>
                <c:pt idx="11">
                  <c:v>Blood transfusion</c:v>
                </c:pt>
                <c:pt idx="12">
                  <c:v>Inotrope(IV)</c:v>
                </c:pt>
                <c:pt idx="13">
                  <c:v>LVAD</c:v>
                </c:pt>
              </c:strCache>
            </c:strRef>
          </c:cat>
          <c:val>
            <c:numRef>
              <c:f>'事前DT→BTT21年後解析(n=5) '!$B$29:$O$29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F42-D248-8EA4-D87C9159A5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0299472"/>
        <c:axId val="2090289680"/>
      </c:barChart>
      <c:catAx>
        <c:axId val="20902994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5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89680"/>
        <c:crosses val="autoZero"/>
        <c:auto val="1"/>
        <c:lblAlgn val="ctr"/>
        <c:lblOffset val="100"/>
        <c:noMultiLvlLbl val="0"/>
      </c:catAx>
      <c:valAx>
        <c:axId val="2090289680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9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事前2解析(n=8) '!$F$8:$K$8</c:f>
              <c:strCache>
                <c:ptCount val="6"/>
                <c:pt idx="0">
                  <c:v>Avoid showing weakness</c:v>
                </c:pt>
                <c:pt idx="1">
                  <c:v>Live in quiet space</c:v>
                </c:pt>
                <c:pt idx="2">
                  <c:v>Treated by all medical measures</c:v>
                </c:pt>
                <c:pt idx="3">
                  <c:v>Eat and use toilet by myself</c:v>
                </c:pt>
                <c:pt idx="4">
                  <c:v>Live without other's help as possible</c:v>
                </c:pt>
                <c:pt idx="5">
                  <c:v> With my loved one</c:v>
                </c:pt>
              </c:strCache>
            </c:strRef>
          </c:cat>
          <c:val>
            <c:numRef>
              <c:f>'事前2解析(n=8) '!$F$9:$K$9</c:f>
              <c:numCache>
                <c:formatCode>General</c:formatCode>
                <c:ptCount val="6"/>
                <c:pt idx="0">
                  <c:v>0</c:v>
                </c:pt>
                <c:pt idx="1">
                  <c:v>42.857142857142854</c:v>
                </c:pt>
                <c:pt idx="2">
                  <c:v>42.857142857142854</c:v>
                </c:pt>
                <c:pt idx="3">
                  <c:v>71.428571428571431</c:v>
                </c:pt>
                <c:pt idx="4">
                  <c:v>71.428571428571431</c:v>
                </c:pt>
                <c:pt idx="5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0F7-0C4D-83D2-205E3BADCB11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87"/>
        <c:overlap val="6"/>
        <c:axId val="2090290224"/>
        <c:axId val="2090297840"/>
      </c:barChart>
      <c:catAx>
        <c:axId val="20902902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0"/>
          <a:lstStyle/>
          <a:p>
            <a:pPr>
              <a:defRPr lang="ja-JP" sz="13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7840"/>
        <c:crosses val="autoZero"/>
        <c:auto val="1"/>
        <c:lblAlgn val="ctr"/>
        <c:lblOffset val="100"/>
        <c:noMultiLvlLbl val="0"/>
      </c:catAx>
      <c:valAx>
        <c:axId val="2090297840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0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事後2解析 Pure DT1年後(n=8)  '!$F$8:$K$8</c:f>
              <c:strCache>
                <c:ptCount val="6"/>
                <c:pt idx="0">
                  <c:v>Avoid showing weakness</c:v>
                </c:pt>
                <c:pt idx="1">
                  <c:v>Live in quiet space</c:v>
                </c:pt>
                <c:pt idx="2">
                  <c:v>Treated by all medical measures</c:v>
                </c:pt>
                <c:pt idx="3">
                  <c:v>Eat and use toilet by myself</c:v>
                </c:pt>
                <c:pt idx="4">
                  <c:v>Live without other's help as possible</c:v>
                </c:pt>
                <c:pt idx="5">
                  <c:v> With my loved one</c:v>
                </c:pt>
              </c:strCache>
            </c:strRef>
          </c:cat>
          <c:val>
            <c:numRef>
              <c:f>'事後2解析 Pure DT1年後(n=8)  '!$F$9:$K$9</c:f>
              <c:numCache>
                <c:formatCode>General</c:formatCode>
                <c:ptCount val="6"/>
                <c:pt idx="0">
                  <c:v>0</c:v>
                </c:pt>
                <c:pt idx="1">
                  <c:v>42.857142857142854</c:v>
                </c:pt>
                <c:pt idx="2">
                  <c:v>42.857142857142854</c:v>
                </c:pt>
                <c:pt idx="3">
                  <c:v>85.714285714285708</c:v>
                </c:pt>
                <c:pt idx="4">
                  <c:v>85.714285714285708</c:v>
                </c:pt>
                <c:pt idx="5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767-1C47-8BEE-F7C9D4BB60B6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87"/>
        <c:overlap val="6"/>
        <c:axId val="2090303280"/>
        <c:axId val="2090290768"/>
      </c:barChart>
      <c:catAx>
        <c:axId val="20903032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0"/>
          <a:lstStyle/>
          <a:p>
            <a:pPr>
              <a:defRPr lang="ja-JP" sz="13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0768"/>
        <c:crosses val="autoZero"/>
        <c:auto val="1"/>
        <c:lblAlgn val="ctr"/>
        <c:lblOffset val="100"/>
        <c:noMultiLvlLbl val="0"/>
      </c:catAx>
      <c:valAx>
        <c:axId val="2090290768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303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事前DT→BTT21年後解析(n=5) '!$F$8:$K$8</c:f>
              <c:strCache>
                <c:ptCount val="6"/>
                <c:pt idx="0">
                  <c:v>Avoid showing weakness</c:v>
                </c:pt>
                <c:pt idx="1">
                  <c:v>Live in quiet space</c:v>
                </c:pt>
                <c:pt idx="2">
                  <c:v>Treated by all medical measures</c:v>
                </c:pt>
                <c:pt idx="3">
                  <c:v>Eat and use toilet by myself</c:v>
                </c:pt>
                <c:pt idx="4">
                  <c:v>Live without other's help as possible</c:v>
                </c:pt>
                <c:pt idx="5">
                  <c:v> With my loved one</c:v>
                </c:pt>
              </c:strCache>
            </c:strRef>
          </c:cat>
          <c:val>
            <c:numRef>
              <c:f>'事前DT→BTT21年後解析(n=5) '!$F$9:$K$9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25</c:v>
                </c:pt>
                <c:pt idx="3">
                  <c:v>25</c:v>
                </c:pt>
                <c:pt idx="4">
                  <c:v>25</c:v>
                </c:pt>
                <c:pt idx="5">
                  <c:v>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FA6-AB4E-A6F1-4DF527A13DE9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87"/>
        <c:overlap val="6"/>
        <c:axId val="2090288048"/>
        <c:axId val="2090295120"/>
      </c:barChart>
      <c:catAx>
        <c:axId val="20902880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0"/>
          <a:lstStyle/>
          <a:p>
            <a:pPr>
              <a:defRPr lang="ja-JP" sz="13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95120"/>
        <c:crosses val="autoZero"/>
        <c:auto val="1"/>
        <c:lblAlgn val="ctr"/>
        <c:lblOffset val="100"/>
        <c:noMultiLvlLbl val="0"/>
      </c:catAx>
      <c:valAx>
        <c:axId val="2090295120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endParaRPr lang="en-US"/>
          </a:p>
        </c:txPr>
        <c:crossAx val="2090288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4E6CC7-6A32-404C-BBAA-3FD9A3C61095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46A757-DD51-AB44-9466-FEFD0403C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520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C4A6DB6-CD4C-DF42-B8C3-F89284E8D7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8A04C6D6-52BF-6446-ADD0-4DFE9067DA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0236E71-564C-6543-A6ED-E99904CB7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0AB2260-CAAC-4149-B0E4-D83050E51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60B67D7-E450-CE49-895E-0CA0D5A54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208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C54F622-2A58-2349-9C56-CFE29D4D61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229ACA8D-6C10-D24C-A47F-C825CF8BF9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E86827A-ACFA-004C-9D4A-C90355A0E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61DB2FD-BCBC-2745-9088-ABD6DEC40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575F7F8-6380-D541-BF7B-F3BB8C290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2106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0A979C49-D267-F840-BA11-75D137D753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CC9C779C-9533-E940-A634-F7F18F45A8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1CA11C2-A943-A744-A472-B7DBB673D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1FA9DF7-2D54-F842-BF7A-7ED176030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6EDD982-3561-364E-B5A3-C62E43F67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498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DDD4D7A-CDA3-8C41-94A3-F0048D5E6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04BF46F9-D56C-E143-95AE-F100321C97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0BE5692-ADE0-564D-8ECE-FBE3B3340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E91CB66-112D-B545-85C4-1DB91E746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C019BF1-F66A-834D-864F-AD6BD363A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175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019F08C-B6E0-3D40-87AA-2AE1085B39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44A11D74-A7CF-6241-A9D8-E1F729EA25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2A3D7D9-A152-2A46-88BF-AC79AC9DE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6B3B23F-EC50-3746-A8B0-9AA094CD4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1CE29C3-97E6-EA4F-86C4-A677B8487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855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35AC0B9-3B6E-7544-84EA-D6AF92461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348AF8F4-DD39-934E-9F95-2AEB2FDFD7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8CA740D2-A80A-3542-B1F9-A4490841B7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6AB3049-9D23-214A-8B2C-3D1EAFBE9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9902755D-35E3-F24F-AC63-A16B28DFE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AFBD675-2A51-7144-B88C-ADDC51694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498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7E5C7A2-4F29-E54C-B1E4-4A9A1CF486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5DCD0A1C-5033-2743-9D0D-540B964904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6633E8A2-79AE-AC42-B72C-CB31E3C327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25B88286-DCC9-984E-B8B3-07FB04F163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DD70DC27-C046-544B-9D70-DC4556D1C6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EE87E74B-C529-1F46-8DAF-63B6EC4BB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56E7CC6F-CA70-334A-9162-FDFB484FE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E4BCBDAA-0F27-474D-BF61-F380DCB43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4862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6695059-1502-8F44-B6F1-263195B6A7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1C584345-A4EB-5146-85F5-BDD8972A6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7984738B-F5C1-5142-9681-53B29FBD0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9A611C72-1DBE-324E-8757-12E577528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134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82777417-F7E1-6C4F-B95F-11648DF27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3D085FAB-0E2B-4F47-8AFE-2966A66B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78A096F8-3763-E248-A869-2E9B3E068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610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0A3AFD1-0035-0C40-9B2D-7304DD351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32F22FB7-40E6-9043-9296-C41FE883F2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1C555409-19FD-6C45-BDF7-386DB25E7D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C8A90512-4676-7B42-991B-8F0882BBB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847FEDEA-5AF9-D44A-B2E8-78908A3D7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28732BDD-3E4D-1041-835E-836036159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2397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2B8F4E3-4544-954A-ACF7-CDF92EE9A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8A553EEC-E260-7241-A54C-380B6003D0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04820452-DFEF-134A-8C35-52BB7B298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4251E4F-68BD-AA4F-95D3-BEF268CEA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6052168C-9FCA-CB44-9AF5-7AF272FAF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85B2C58-5AD9-F240-AB1B-455CC6DA4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688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A613C51B-A06F-2044-87E7-042F5E2DBC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58B65F2E-6ACB-5A4D-8367-6BC9FED06C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5D79E52-1C40-854A-BFCB-354AA285B2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23166-FD41-8E45-B646-CA23657D788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D8C5160-0A16-B841-8C03-115361C617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964D246-44F0-0C46-8520-B722AFB3F2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A6EC6-8771-6C4B-BCF5-D60FEEC328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6359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xmlns="" id="{18FCD0F0-BD45-9843-9993-1ED89EDF4D5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879853" y="501513"/>
          <a:ext cx="5760000" cy="61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xmlns="" id="{88A56C34-ADC1-AD47-AD3B-3829ABCE6369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11293" y="501513"/>
          <a:ext cx="5760000" cy="61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2AEED89A-E564-494B-ADB2-515F4FE5D419}"/>
              </a:ext>
            </a:extLst>
          </p:cNvPr>
          <p:cNvSpPr txBox="1"/>
          <p:nvPr/>
        </p:nvSpPr>
        <p:spPr>
          <a:xfrm>
            <a:off x="2308232" y="27999"/>
            <a:ext cx="335021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t timing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906E5EBB-2869-2C45-BF6B-D38DAB62ADE1}"/>
              </a:ext>
            </a:extLst>
          </p:cNvPr>
          <p:cNvSpPr txBox="1"/>
          <p:nvPr/>
        </p:nvSpPr>
        <p:spPr>
          <a:xfrm>
            <a:off x="7775269" y="27999"/>
            <a:ext cx="38645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fter </a:t>
            </a:r>
            <a:r>
              <a:rPr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one</a:t>
            </a:r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 year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57530B2C-35A9-8142-9234-48BC4E268667}"/>
              </a:ext>
            </a:extLst>
          </p:cNvPr>
          <p:cNvSpPr/>
          <p:nvPr/>
        </p:nvSpPr>
        <p:spPr>
          <a:xfrm>
            <a:off x="9850589" y="6617973"/>
            <a:ext cx="24505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Meiryo" panose="020B0604030504040204" pitchFamily="34" charset="-128"/>
                <a:ea typeface="Meiryo" panose="020B0604030504040204" pitchFamily="34" charset="-128"/>
              </a:rPr>
              <a:t>Supplementary Figure 1A</a:t>
            </a:r>
            <a:endParaRPr lang="ja-JP" altLang="en-US" sz="140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C5FB0BA0-5D06-EF46-A5D3-720A5C869764}"/>
              </a:ext>
            </a:extLst>
          </p:cNvPr>
          <p:cNvSpPr txBox="1"/>
          <p:nvPr/>
        </p:nvSpPr>
        <p:spPr>
          <a:xfrm>
            <a:off x="5866414" y="6264216"/>
            <a:ext cx="5934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(%)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B0F76F4C-D015-DB40-8E40-33E045C58C26}"/>
              </a:ext>
            </a:extLst>
          </p:cNvPr>
          <p:cNvSpPr txBox="1"/>
          <p:nvPr/>
        </p:nvSpPr>
        <p:spPr>
          <a:xfrm>
            <a:off x="11486165" y="6264216"/>
            <a:ext cx="5934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(%)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3F1126ED-17C2-8A4C-90CA-F2DF0EA31BD8}"/>
              </a:ext>
            </a:extLst>
          </p:cNvPr>
          <p:cNvSpPr txBox="1"/>
          <p:nvPr/>
        </p:nvSpPr>
        <p:spPr>
          <a:xfrm>
            <a:off x="1949029" y="339930"/>
            <a:ext cx="117346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I prefer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A3CBA1E1-6137-334E-825E-92A84F7B7D2E}"/>
              </a:ext>
            </a:extLst>
          </p:cNvPr>
          <p:cNvSpPr txBox="1"/>
          <p:nvPr/>
        </p:nvSpPr>
        <p:spPr>
          <a:xfrm>
            <a:off x="3122492" y="339930"/>
            <a:ext cx="168251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know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02D4B2E0-50C0-E64E-BA51-10DB1B4C85E7}"/>
              </a:ext>
            </a:extLst>
          </p:cNvPr>
          <p:cNvSpPr txBox="1"/>
          <p:nvPr/>
        </p:nvSpPr>
        <p:spPr>
          <a:xfrm>
            <a:off x="4783522" y="358259"/>
            <a:ext cx="175791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prefer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2E23A938-CDDA-BC44-A7C1-1C8752E4364F}"/>
              </a:ext>
            </a:extLst>
          </p:cNvPr>
          <p:cNvSpPr txBox="1"/>
          <p:nvPr/>
        </p:nvSpPr>
        <p:spPr>
          <a:xfrm>
            <a:off x="7609944" y="323401"/>
            <a:ext cx="117346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I prefer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4C67DD82-BEF9-5E4D-A61F-0D703D9471CA}"/>
              </a:ext>
            </a:extLst>
          </p:cNvPr>
          <p:cNvSpPr txBox="1"/>
          <p:nvPr/>
        </p:nvSpPr>
        <p:spPr>
          <a:xfrm>
            <a:off x="8783407" y="323401"/>
            <a:ext cx="168251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know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BF382797-EFCD-0746-9EC2-A57BB6DDB2AB}"/>
              </a:ext>
            </a:extLst>
          </p:cNvPr>
          <p:cNvSpPr txBox="1"/>
          <p:nvPr/>
        </p:nvSpPr>
        <p:spPr>
          <a:xfrm>
            <a:off x="10444437" y="341730"/>
            <a:ext cx="175791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prefer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xmlns="" id="{08A1416B-EFBA-9241-9870-AB02EF0D8E93}"/>
              </a:ext>
            </a:extLst>
          </p:cNvPr>
          <p:cNvCxnSpPr>
            <a:cxnSpLocks/>
          </p:cNvCxnSpPr>
          <p:nvPr/>
        </p:nvCxnSpPr>
        <p:spPr>
          <a:xfrm>
            <a:off x="1949029" y="609990"/>
            <a:ext cx="1173463" cy="0"/>
          </a:xfrm>
          <a:prstGeom prst="line">
            <a:avLst/>
          </a:prstGeom>
          <a:ln w="381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xmlns="" id="{9E732BBB-6D6A-4A48-96D6-3041E1BD5867}"/>
              </a:ext>
            </a:extLst>
          </p:cNvPr>
          <p:cNvCxnSpPr>
            <a:cxnSpLocks/>
          </p:cNvCxnSpPr>
          <p:nvPr/>
        </p:nvCxnSpPr>
        <p:spPr>
          <a:xfrm>
            <a:off x="3214612" y="609990"/>
            <a:ext cx="1456779" cy="0"/>
          </a:xfrm>
          <a:prstGeom prst="line">
            <a:avLst/>
          </a:prstGeom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xmlns="" id="{7486B6B4-A605-E040-ABF3-23E260B21DCB}"/>
              </a:ext>
            </a:extLst>
          </p:cNvPr>
          <p:cNvCxnSpPr>
            <a:cxnSpLocks/>
          </p:cNvCxnSpPr>
          <p:nvPr/>
        </p:nvCxnSpPr>
        <p:spPr>
          <a:xfrm>
            <a:off x="4874577" y="609990"/>
            <a:ext cx="1585269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xmlns="" id="{635F882E-B2B3-D441-8F2E-318B9F2EB072}"/>
              </a:ext>
            </a:extLst>
          </p:cNvPr>
          <p:cNvCxnSpPr>
            <a:cxnSpLocks/>
          </p:cNvCxnSpPr>
          <p:nvPr/>
        </p:nvCxnSpPr>
        <p:spPr>
          <a:xfrm>
            <a:off x="7609944" y="597128"/>
            <a:ext cx="1173463" cy="0"/>
          </a:xfrm>
          <a:prstGeom prst="line">
            <a:avLst/>
          </a:prstGeom>
          <a:ln w="381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xmlns="" id="{5EC71CBE-A95D-C341-992B-AEE8FE70DEBD}"/>
              </a:ext>
            </a:extLst>
          </p:cNvPr>
          <p:cNvCxnSpPr>
            <a:cxnSpLocks/>
          </p:cNvCxnSpPr>
          <p:nvPr/>
        </p:nvCxnSpPr>
        <p:spPr>
          <a:xfrm>
            <a:off x="8875527" y="597128"/>
            <a:ext cx="1456779" cy="0"/>
          </a:xfrm>
          <a:prstGeom prst="line">
            <a:avLst/>
          </a:prstGeom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xmlns="" id="{6833F731-01C5-554D-8BEB-356157B02186}"/>
              </a:ext>
            </a:extLst>
          </p:cNvPr>
          <p:cNvCxnSpPr>
            <a:cxnSpLocks/>
          </p:cNvCxnSpPr>
          <p:nvPr/>
        </p:nvCxnSpPr>
        <p:spPr>
          <a:xfrm>
            <a:off x="10535492" y="597128"/>
            <a:ext cx="1585269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99726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xmlns="" id="{7A0C863A-D518-BF4F-98E9-5666B4B175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1595574"/>
              </p:ext>
            </p:extLst>
          </p:nvPr>
        </p:nvGraphicFramePr>
        <p:xfrm>
          <a:off x="281454" y="467381"/>
          <a:ext cx="5760000" cy="61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xmlns="" id="{AF41FF6B-FFE2-A64E-B8F4-50295191DF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270078"/>
              </p:ext>
            </p:extLst>
          </p:nvPr>
        </p:nvGraphicFramePr>
        <p:xfrm>
          <a:off x="5892048" y="487943"/>
          <a:ext cx="5760000" cy="61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A5426DA7-93CE-E34A-B9E2-BA862F87D41A}"/>
              </a:ext>
            </a:extLst>
          </p:cNvPr>
          <p:cNvSpPr txBox="1"/>
          <p:nvPr/>
        </p:nvSpPr>
        <p:spPr>
          <a:xfrm>
            <a:off x="7220956" y="4596571"/>
            <a:ext cx="4125565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Meiryo" panose="020B0604030504040204" pitchFamily="34" charset="-128"/>
                <a:ea typeface="Meiryo" panose="020B0604030504040204" pitchFamily="34" charset="-128"/>
              </a:rPr>
              <a:t>Difficult to assess due to modifications in advance directives for bridge to transplant.</a:t>
            </a:r>
            <a:endParaRPr kumimoji="1" lang="en-US" altLang="ja-JP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FB7E691E-4997-8C43-BD5C-667DF359E7D9}"/>
              </a:ext>
            </a:extLst>
          </p:cNvPr>
          <p:cNvSpPr txBox="1"/>
          <p:nvPr/>
        </p:nvSpPr>
        <p:spPr>
          <a:xfrm>
            <a:off x="7220956" y="1381486"/>
            <a:ext cx="412556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Meiryo" panose="020B0604030504040204" pitchFamily="34" charset="-128"/>
                <a:ea typeface="Meiryo" panose="020B0604030504040204" pitchFamily="34" charset="-128"/>
              </a:rPr>
              <a:t>Difficult to assess (Reason below)</a:t>
            </a:r>
            <a:endParaRPr kumimoji="1" lang="en-US" altLang="ja-JP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90A4BCFA-416C-A44F-90F3-34A73CA9DE27}"/>
              </a:ext>
            </a:extLst>
          </p:cNvPr>
          <p:cNvSpPr/>
          <p:nvPr/>
        </p:nvSpPr>
        <p:spPr>
          <a:xfrm>
            <a:off x="9850589" y="6617973"/>
            <a:ext cx="24505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Meiryo" panose="020B0604030504040204" pitchFamily="34" charset="-128"/>
                <a:ea typeface="Meiryo" panose="020B0604030504040204" pitchFamily="34" charset="-128"/>
              </a:rPr>
              <a:t>Supplementary Figure 1B</a:t>
            </a:r>
            <a:endParaRPr lang="ja-JP" altLang="en-US" sz="140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3EDFE7F5-D5F5-3440-8905-6D39526722CE}"/>
              </a:ext>
            </a:extLst>
          </p:cNvPr>
          <p:cNvSpPr txBox="1"/>
          <p:nvPr/>
        </p:nvSpPr>
        <p:spPr>
          <a:xfrm>
            <a:off x="5866414" y="6264216"/>
            <a:ext cx="5934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(%)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FAF2104A-F366-774D-9EAA-A0E400AF0B91}"/>
              </a:ext>
            </a:extLst>
          </p:cNvPr>
          <p:cNvSpPr txBox="1"/>
          <p:nvPr/>
        </p:nvSpPr>
        <p:spPr>
          <a:xfrm>
            <a:off x="11486165" y="6264216"/>
            <a:ext cx="5934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(%)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9A5C2994-CDD8-BF4C-92C2-167E35DC9043}"/>
              </a:ext>
            </a:extLst>
          </p:cNvPr>
          <p:cNvSpPr txBox="1"/>
          <p:nvPr/>
        </p:nvSpPr>
        <p:spPr>
          <a:xfrm>
            <a:off x="2308232" y="27999"/>
            <a:ext cx="335021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t timing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071C8125-39F8-DE43-8FA8-DC78245835A4}"/>
              </a:ext>
            </a:extLst>
          </p:cNvPr>
          <p:cNvSpPr txBox="1"/>
          <p:nvPr/>
        </p:nvSpPr>
        <p:spPr>
          <a:xfrm>
            <a:off x="7775269" y="27999"/>
            <a:ext cx="38645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fter </a:t>
            </a:r>
            <a:r>
              <a:rPr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one</a:t>
            </a:r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 year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51FF57F5-8A93-0749-BD4C-8B8588491D05}"/>
              </a:ext>
            </a:extLst>
          </p:cNvPr>
          <p:cNvSpPr txBox="1"/>
          <p:nvPr/>
        </p:nvSpPr>
        <p:spPr>
          <a:xfrm>
            <a:off x="1949029" y="339930"/>
            <a:ext cx="117346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I prefer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52D34A6D-B3C2-A84F-8F7C-823FEB6071A2}"/>
              </a:ext>
            </a:extLst>
          </p:cNvPr>
          <p:cNvSpPr txBox="1"/>
          <p:nvPr/>
        </p:nvSpPr>
        <p:spPr>
          <a:xfrm>
            <a:off x="3122492" y="339930"/>
            <a:ext cx="168251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know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D0C721D7-12F7-8943-98A2-284A6C309176}"/>
              </a:ext>
            </a:extLst>
          </p:cNvPr>
          <p:cNvSpPr txBox="1"/>
          <p:nvPr/>
        </p:nvSpPr>
        <p:spPr>
          <a:xfrm>
            <a:off x="4783522" y="358259"/>
            <a:ext cx="175791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prefer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BE16AABD-80FF-A540-9D3C-B253621A02A1}"/>
              </a:ext>
            </a:extLst>
          </p:cNvPr>
          <p:cNvSpPr txBox="1"/>
          <p:nvPr/>
        </p:nvSpPr>
        <p:spPr>
          <a:xfrm>
            <a:off x="7609944" y="323401"/>
            <a:ext cx="117346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I prefer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A3DEF00C-AA52-2448-A173-1C2CB15F6DF0}"/>
              </a:ext>
            </a:extLst>
          </p:cNvPr>
          <p:cNvSpPr txBox="1"/>
          <p:nvPr/>
        </p:nvSpPr>
        <p:spPr>
          <a:xfrm>
            <a:off x="8783407" y="323401"/>
            <a:ext cx="168251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know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07183AA1-B29E-B347-BE72-F93E444BDDE2}"/>
              </a:ext>
            </a:extLst>
          </p:cNvPr>
          <p:cNvSpPr txBox="1"/>
          <p:nvPr/>
        </p:nvSpPr>
        <p:spPr>
          <a:xfrm>
            <a:off x="10444437" y="341730"/>
            <a:ext cx="175791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“</a:t>
            </a:r>
            <a:r>
              <a:rPr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I don’t prefer</a:t>
            </a:r>
            <a:r>
              <a:rPr kumimoji="1" lang="en-US" altLang="ja-JP" sz="1500" b="1" i="1" dirty="0">
                <a:latin typeface="Meiryo" panose="020B0604030504040204" pitchFamily="34" charset="-128"/>
                <a:ea typeface="Meiryo" panose="020B0604030504040204" pitchFamily="34" charset="-128"/>
              </a:rPr>
              <a:t>”</a:t>
            </a:r>
            <a:endParaRPr kumimoji="1" lang="ja-JP" altLang="en-US" sz="1500" b="1" i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xmlns="" id="{D469181B-DEF0-1441-A188-8DF5B5D659FC}"/>
              </a:ext>
            </a:extLst>
          </p:cNvPr>
          <p:cNvCxnSpPr>
            <a:cxnSpLocks/>
          </p:cNvCxnSpPr>
          <p:nvPr/>
        </p:nvCxnSpPr>
        <p:spPr>
          <a:xfrm>
            <a:off x="1949029" y="609990"/>
            <a:ext cx="1173463" cy="0"/>
          </a:xfrm>
          <a:prstGeom prst="line">
            <a:avLst/>
          </a:prstGeom>
          <a:ln w="381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xmlns="" id="{2FC2F2EC-F0AB-BE4D-924E-0C4CEF438907}"/>
              </a:ext>
            </a:extLst>
          </p:cNvPr>
          <p:cNvCxnSpPr>
            <a:cxnSpLocks/>
          </p:cNvCxnSpPr>
          <p:nvPr/>
        </p:nvCxnSpPr>
        <p:spPr>
          <a:xfrm>
            <a:off x="3214612" y="609990"/>
            <a:ext cx="1456779" cy="0"/>
          </a:xfrm>
          <a:prstGeom prst="line">
            <a:avLst/>
          </a:prstGeom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xmlns="" id="{CFE644C8-4434-834E-A21B-378ADF6C61AF}"/>
              </a:ext>
            </a:extLst>
          </p:cNvPr>
          <p:cNvCxnSpPr>
            <a:cxnSpLocks/>
          </p:cNvCxnSpPr>
          <p:nvPr/>
        </p:nvCxnSpPr>
        <p:spPr>
          <a:xfrm>
            <a:off x="4874577" y="609990"/>
            <a:ext cx="1585269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xmlns="" id="{81262086-F787-CD47-944A-56B13424E140}"/>
              </a:ext>
            </a:extLst>
          </p:cNvPr>
          <p:cNvCxnSpPr>
            <a:cxnSpLocks/>
          </p:cNvCxnSpPr>
          <p:nvPr/>
        </p:nvCxnSpPr>
        <p:spPr>
          <a:xfrm>
            <a:off x="7609944" y="592891"/>
            <a:ext cx="1173463" cy="0"/>
          </a:xfrm>
          <a:prstGeom prst="line">
            <a:avLst/>
          </a:prstGeom>
          <a:ln w="381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xmlns="" id="{2C793604-4B09-EA45-B365-9EB39770670B}"/>
              </a:ext>
            </a:extLst>
          </p:cNvPr>
          <p:cNvCxnSpPr>
            <a:cxnSpLocks/>
          </p:cNvCxnSpPr>
          <p:nvPr/>
        </p:nvCxnSpPr>
        <p:spPr>
          <a:xfrm>
            <a:off x="8875527" y="592891"/>
            <a:ext cx="1456779" cy="0"/>
          </a:xfrm>
          <a:prstGeom prst="line">
            <a:avLst/>
          </a:prstGeom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xmlns="" id="{03263792-E77A-C94C-9000-41D4B33D12BD}"/>
              </a:ext>
            </a:extLst>
          </p:cNvPr>
          <p:cNvCxnSpPr>
            <a:cxnSpLocks/>
          </p:cNvCxnSpPr>
          <p:nvPr/>
        </p:nvCxnSpPr>
        <p:spPr>
          <a:xfrm>
            <a:off x="10535492" y="592891"/>
            <a:ext cx="1585269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0891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xmlns="" id="{AE8E49A8-5374-8A4D-BBC6-4AB87E6CB7D4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18016" y="1076325"/>
          <a:ext cx="6120000" cy="4730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xmlns="" id="{79D054F4-7512-E443-A596-E0640B789CCB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072000" y="1085850"/>
          <a:ext cx="6120000" cy="4730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95E93771-CAA3-8340-A924-7B1F727D4E2A}"/>
              </a:ext>
            </a:extLst>
          </p:cNvPr>
          <p:cNvSpPr txBox="1"/>
          <p:nvPr/>
        </p:nvSpPr>
        <p:spPr>
          <a:xfrm>
            <a:off x="5662831" y="572903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Meiryo" panose="020B0604030504040204" pitchFamily="34" charset="-128"/>
                <a:ea typeface="Meiryo" panose="020B0604030504040204" pitchFamily="34" charset="-128"/>
              </a:rPr>
              <a:t>(%)</a:t>
            </a:r>
            <a:endParaRPr kumimoji="1" lang="ja-JP" altLang="en-US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12802E7D-0104-EF49-BBFB-05785DEB1902}"/>
              </a:ext>
            </a:extLst>
          </p:cNvPr>
          <p:cNvSpPr txBox="1"/>
          <p:nvPr/>
        </p:nvSpPr>
        <p:spPr>
          <a:xfrm>
            <a:off x="11516815" y="572903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Meiryo" panose="020B0604030504040204" pitchFamily="34" charset="-128"/>
                <a:ea typeface="Meiryo" panose="020B0604030504040204" pitchFamily="34" charset="-128"/>
              </a:rPr>
              <a:t>(%)</a:t>
            </a:r>
            <a:endParaRPr kumimoji="1" lang="ja-JP" altLang="en-US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2D5C084D-B0F4-5D40-9098-7AE68DE8A9E1}"/>
              </a:ext>
            </a:extLst>
          </p:cNvPr>
          <p:cNvSpPr txBox="1"/>
          <p:nvPr/>
        </p:nvSpPr>
        <p:spPr>
          <a:xfrm>
            <a:off x="2618238" y="624465"/>
            <a:ext cx="335021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t timing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3A78FCF0-0AC1-7040-9AF5-664BE772B9EA}"/>
              </a:ext>
            </a:extLst>
          </p:cNvPr>
          <p:cNvSpPr txBox="1"/>
          <p:nvPr/>
        </p:nvSpPr>
        <p:spPr>
          <a:xfrm>
            <a:off x="8213968" y="624465"/>
            <a:ext cx="38645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fter </a:t>
            </a:r>
            <a:r>
              <a:rPr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one</a:t>
            </a:r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 year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xmlns="" id="{70321942-ED9D-1846-A342-D5B3F703E129}"/>
              </a:ext>
            </a:extLst>
          </p:cNvPr>
          <p:cNvSpPr/>
          <p:nvPr/>
        </p:nvSpPr>
        <p:spPr>
          <a:xfrm>
            <a:off x="9850589" y="6617973"/>
            <a:ext cx="24505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Meiryo" panose="020B0604030504040204" pitchFamily="34" charset="-128"/>
                <a:ea typeface="Meiryo" panose="020B0604030504040204" pitchFamily="34" charset="-128"/>
              </a:rPr>
              <a:t>Supplementary Figure 2A</a:t>
            </a:r>
            <a:endParaRPr lang="ja-JP" altLang="en-US" sz="140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975186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xmlns="" id="{326E9BAB-F64C-424F-A37C-BCA1CB85CF0B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44113" y="1076039"/>
          <a:ext cx="6120000" cy="47821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48D3D01E-5408-2A41-B2AA-D9262285B189}"/>
              </a:ext>
            </a:extLst>
          </p:cNvPr>
          <p:cNvSpPr txBox="1"/>
          <p:nvPr/>
        </p:nvSpPr>
        <p:spPr>
          <a:xfrm>
            <a:off x="5788928" y="5801903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Meiryo" panose="020B0604030504040204" pitchFamily="34" charset="-128"/>
                <a:ea typeface="Meiryo" panose="020B0604030504040204" pitchFamily="34" charset="-128"/>
              </a:rPr>
              <a:t>(%)</a:t>
            </a:r>
            <a:endParaRPr kumimoji="1" lang="ja-JP" altLang="en-US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DDBCCD7F-D913-704D-9DBF-3CAF6782C9BD}"/>
              </a:ext>
            </a:extLst>
          </p:cNvPr>
          <p:cNvSpPr txBox="1"/>
          <p:nvPr/>
        </p:nvSpPr>
        <p:spPr>
          <a:xfrm>
            <a:off x="2618238" y="624465"/>
            <a:ext cx="335021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t timing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90431254-A249-664D-86C0-21E562BF852D}"/>
              </a:ext>
            </a:extLst>
          </p:cNvPr>
          <p:cNvSpPr txBox="1"/>
          <p:nvPr/>
        </p:nvSpPr>
        <p:spPr>
          <a:xfrm>
            <a:off x="7814742" y="624465"/>
            <a:ext cx="38645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After </a:t>
            </a:r>
            <a:r>
              <a:rPr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one</a:t>
            </a:r>
            <a:r>
              <a:rPr kumimoji="1" lang="en-US" altLang="ja-JP" sz="1500" b="1" dirty="0">
                <a:latin typeface="Meiryo" panose="020B0604030504040204" pitchFamily="34" charset="-128"/>
                <a:ea typeface="Meiryo" panose="020B0604030504040204" pitchFamily="34" charset="-128"/>
              </a:rPr>
              <a:t> year of LVAD implantation</a:t>
            </a:r>
            <a:endParaRPr kumimoji="1" lang="ja-JP" altLang="en-US" sz="15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D6856786-59CC-4E46-881D-DB31FAD51545}"/>
              </a:ext>
            </a:extLst>
          </p:cNvPr>
          <p:cNvSpPr txBox="1"/>
          <p:nvPr/>
        </p:nvSpPr>
        <p:spPr>
          <a:xfrm>
            <a:off x="7684252" y="3005434"/>
            <a:ext cx="4125565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Meiryo" panose="020B0604030504040204" pitchFamily="34" charset="-128"/>
                <a:ea typeface="Meiryo" panose="020B0604030504040204" pitchFamily="34" charset="-128"/>
              </a:rPr>
              <a:t>Difficult to assess due to modifications in advance directives for bridge to transplant.</a:t>
            </a:r>
            <a:endParaRPr kumimoji="1" lang="en-US" altLang="ja-JP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xmlns="" id="{5E1C3A53-4D37-A243-BABB-CD4B251E706C}"/>
              </a:ext>
            </a:extLst>
          </p:cNvPr>
          <p:cNvSpPr/>
          <p:nvPr/>
        </p:nvSpPr>
        <p:spPr>
          <a:xfrm>
            <a:off x="9850589" y="6617973"/>
            <a:ext cx="24505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Meiryo" panose="020B0604030504040204" pitchFamily="34" charset="-128"/>
                <a:ea typeface="Meiryo" panose="020B0604030504040204" pitchFamily="34" charset="-128"/>
              </a:rPr>
              <a:t>Supplementary Figure 2B</a:t>
            </a:r>
            <a:endParaRPr lang="ja-JP" altLang="en-US" sz="140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354699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436</TotalTime>
  <Words>154</Words>
  <Application>Microsoft Office PowerPoint</Application>
  <PresentationFormat>Widescreen</PresentationFormat>
  <Paragraphs>3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Meiryo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Aswini Vijayakumar</cp:lastModifiedBy>
  <cp:revision>400</cp:revision>
  <cp:lastPrinted>2025-02-09T17:25:36Z</cp:lastPrinted>
  <dcterms:created xsi:type="dcterms:W3CDTF">2025-01-02T23:49:13Z</dcterms:created>
  <dcterms:modified xsi:type="dcterms:W3CDTF">2025-07-06T01:34:00Z</dcterms:modified>
</cp:coreProperties>
</file>